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856"/>
    <p:restoredTop sz="94685"/>
  </p:normalViewPr>
  <p:slideViewPr>
    <p:cSldViewPr snapToGrid="0">
      <p:cViewPr varScale="1">
        <p:scale>
          <a:sx n="56" d="100"/>
          <a:sy n="56" d="100"/>
        </p:scale>
        <p:origin x="216" y="1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96AB9-CA63-8AEE-AD9F-8CE37D27A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D09E99-DEB6-6A80-31C4-4E4875760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E1BDE-F056-2DFA-F995-A346D4E79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15CF4-1456-DA17-B0C0-11B1E3B7D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20C70-AFE6-B0D0-2FDD-C022C85ED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0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174C1-19A2-B2D3-B336-A2250DFA35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BBD1FF-EE8C-A4BC-B19D-D9D1E6967A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E89C9-69A1-08D7-E5DC-FCFF76FDE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8ABB8-91A3-F9E5-3715-A931A5206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949B2-9570-1765-711D-222C176B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27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7CACF4-92E2-E69D-CD5F-F02251597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FF73A7-D44B-8149-B0C9-A10BD663A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236630-9124-BA43-4448-DE74BBCCC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35573-07D7-887B-3BD6-08136B150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4971C-996A-9855-771C-3F89CE943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35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A164C-0FE3-1CB6-0320-7F1579CF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BA3074-A3BA-D37A-516F-0E9515C53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7DC94-7B5C-BA89-6A3E-373E292A3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F91F8-379E-9816-BEAA-BF7F466C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F5482-0961-0C7B-FEB1-85655D630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12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D9B1E-3097-7658-319D-9C5A58B8C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28E0F-0B65-1378-E265-5EFDFD554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0F7EB3-3754-539D-6788-4FD94F05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C080-11F8-B6CE-045E-29F2A22E8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55951-20E7-1017-9C75-81CF7BDC9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94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AC7BA-7B3B-704D-DADD-38BD93390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34805-8E7F-0F18-0D70-4F519AA25C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82A65-B49D-0AE6-9006-1CD7C396B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446160-F456-8B8E-AF7E-153C1A9F9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3332A-EB51-E24F-AD46-938ECD0A1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1CBC18-B633-8344-A15D-F5100A6F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78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6563E-9087-BEAA-6F6C-E6511EB5D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1657D-590A-376B-C045-F5EB4E54A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41A68-AFC5-AB0E-5AB3-0637586C7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5BCFAB-533B-4D60-EF4F-2991CBB7F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84C4F-9B9B-2CCD-9861-697B958DC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1E1722-ACC1-A6D4-53FB-49525262F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1FF02A-9AC2-D580-D6B4-83BE8FD37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003348-A871-92FE-48D0-8703CC14D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66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83A969-4F9B-3D20-F333-8805B8FEC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8338F1-7FE3-AC2A-D162-35B8C197D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08145-6B9F-7B35-15B8-53CD8345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EC5771-3C86-BBA8-ED9D-9AEA64C67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65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40DB0D-4884-B0FA-6C60-451D8407F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AA67AC-C267-3AAC-88EF-AA9743F2D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53D490-B0B5-1E28-CBAF-82383D4D8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5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D6ED0-982C-41D5-7A34-C58FD8BC7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C68C8-741F-7406-9F25-888C5BE78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54FF4-AB34-0765-1D9C-9C4BCE399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E3397-D61D-CEDA-A7D2-44F89A163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69A588-F086-79F5-EF61-7DE927E8B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B72A2-5FA6-5DC9-AFEA-8AACD6287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73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6469D-676B-A09E-C366-0F8A95482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CA4FC-B488-C8EB-8463-4645D9A82A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BBB6D7-83DE-A0E6-7FE0-4A4CB1A17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4A4D87-2555-0DDE-96D3-77729943F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DD891-EEBE-5613-0012-D2C1FE8CE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AC09B5-248A-8DF4-E27B-DEB87792F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2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25BF80-CC22-8091-BB61-DB4BB41F9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A8B1A8-34E8-C37A-C9B5-08FEDA690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65A5E-8218-C129-8C33-27B5913013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B8040C-BF7E-80C3-D71E-0CC4C88A58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685A5-CA66-4128-3CC1-7E6CB892E4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0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70549E-A1DE-9735-8408-293F33C5DB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Video 2">
            <a:hlinkClick r:id="" action="ppaction://media"/>
            <a:extLst>
              <a:ext uri="{FF2B5EF4-FFF2-40B4-BE49-F238E27FC236}">
                <a16:creationId xmlns:a16="http://schemas.microsoft.com/office/drawing/2014/main" id="{5D2428B1-F3B9-BF48-D424-77536ACB912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763" y="7938"/>
            <a:ext cx="930910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FD2AC93-D8E1-5423-94C1-C7CBB928A037}"/>
              </a:ext>
            </a:extLst>
          </p:cNvPr>
          <p:cNvSpPr txBox="1"/>
          <p:nvPr/>
        </p:nvSpPr>
        <p:spPr>
          <a:xfrm flipH="1">
            <a:off x="9738359" y="1120140"/>
            <a:ext cx="2115820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deo 2: </a:t>
            </a:r>
            <a: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ical 3 chamber view with color Doppler by transthoracic echocardiography on day 0 post-valve implantation. No significant paravalvular stenosis and trace paravalvular regurgitation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7652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5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</Words>
  <Application>Microsoft Macintosh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2</cp:revision>
  <dcterms:created xsi:type="dcterms:W3CDTF">2025-04-14T20:40:00Z</dcterms:created>
  <dcterms:modified xsi:type="dcterms:W3CDTF">2025-04-14T20:41:27Z</dcterms:modified>
</cp:coreProperties>
</file>